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1061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Renji\Muscle perfusion\paper\JCMR\Major Revision\Statitics\Figure\ASL maps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728127"/>
            <a:ext cx="5400000" cy="30185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51520" y="147990"/>
            <a:ext cx="7421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Figure S1: </a:t>
            </a:r>
            <a:r>
              <a:rPr lang="en-US" altLang="zh-CN" sz="1600" dirty="0" smtClean="0"/>
              <a:t>Example of source images and processed maps for ASL, BOLD, and IVIM MRI.</a:t>
            </a:r>
            <a:endParaRPr lang="zh-CN" altLang="en-US" sz="1600" dirty="0"/>
          </a:p>
        </p:txBody>
      </p:sp>
      <p:sp>
        <p:nvSpPr>
          <p:cNvPr id="5" name="矩形 4"/>
          <p:cNvSpPr/>
          <p:nvPr/>
        </p:nvSpPr>
        <p:spPr>
          <a:xfrm>
            <a:off x="4211960" y="1340768"/>
            <a:ext cx="5212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S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68121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Renji\Muscle perfusion\paper\JCMR\Major Revision\Statitics\Figure\BOLD maps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04664"/>
            <a:ext cx="7920000" cy="59528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4211960" y="44624"/>
            <a:ext cx="7024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BOL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54382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D:\Renji\Muscle perfusion\paper\JCMR\Major Revision\Statitics\Figure\IVIM maps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654827"/>
            <a:ext cx="7920000" cy="55104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4139952" y="260648"/>
            <a:ext cx="6286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IVIM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6046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2</Words>
  <Application>Microsoft Office PowerPoint</Application>
  <PresentationFormat>全屏显示(4:3)</PresentationFormat>
  <Paragraphs>4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(null)</cp:lastModifiedBy>
  <cp:revision>4</cp:revision>
  <dcterms:created xsi:type="dcterms:W3CDTF">2017-11-08T06:27:47Z</dcterms:created>
  <dcterms:modified xsi:type="dcterms:W3CDTF">2017-11-10T05:43:23Z</dcterms:modified>
</cp:coreProperties>
</file>